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19931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05" autoAdjust="0"/>
    <p:restoredTop sz="83082" autoAdjust="0"/>
  </p:normalViewPr>
  <p:slideViewPr>
    <p:cSldViewPr snapToGrid="0">
      <p:cViewPr varScale="1">
        <p:scale>
          <a:sx n="63" d="100"/>
          <a:sy n="63" d="100"/>
        </p:scale>
        <p:origin x="4128" y="208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359AD5-3FD2-4334-AA43-651A615B5D64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07AF3E-E226-44AD-A662-4E32329D5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2708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07AF3E-E226-44AD-A662-4E32329D5F7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270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767462"/>
            <a:ext cx="6119416" cy="375991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5672376"/>
            <a:ext cx="5399485" cy="2607442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151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012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574987"/>
            <a:ext cx="1552352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574987"/>
            <a:ext cx="4567064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387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5057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692444"/>
            <a:ext cx="6209407" cy="4492401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7227345"/>
            <a:ext cx="6209407" cy="236244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993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58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574990"/>
            <a:ext cx="6209407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647443"/>
            <a:ext cx="3045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3944914"/>
            <a:ext cx="3045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647443"/>
            <a:ext cx="3060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3944914"/>
            <a:ext cx="3060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079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1655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837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554968"/>
            <a:ext cx="3644652" cy="767483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671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554968"/>
            <a:ext cx="3644652" cy="767483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148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574990"/>
            <a:ext cx="6209407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874937"/>
            <a:ext cx="6209407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0009783"/>
            <a:ext cx="242976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392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kumimoji="1"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FAAECB7-0CFF-5772-9DC6-CA5BCF5CE4B3}"/>
              </a:ext>
            </a:extLst>
          </p:cNvPr>
          <p:cNvSpPr txBox="1"/>
          <p:nvPr/>
        </p:nvSpPr>
        <p:spPr>
          <a:xfrm>
            <a:off x="364671" y="275550"/>
            <a:ext cx="636393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 </a:t>
            </a:r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. </a:t>
            </a:r>
          </a:p>
          <a:p>
            <a:pPr algn="just"/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thods of Calculating presenteeism and absenteeism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4" name="フリーフォーム: 図形 83">
            <a:extLst>
              <a:ext uri="{FF2B5EF4-FFF2-40B4-BE49-F238E27FC236}">
                <a16:creationId xmlns:a16="http://schemas.microsoft.com/office/drawing/2014/main" id="{F6C0E69B-5E6E-5526-12F8-ED670F906BBE}"/>
              </a:ext>
            </a:extLst>
          </p:cNvPr>
          <p:cNvSpPr/>
          <p:nvPr/>
        </p:nvSpPr>
        <p:spPr>
          <a:xfrm>
            <a:off x="337614" y="1161919"/>
            <a:ext cx="6390996" cy="3671337"/>
          </a:xfrm>
          <a:custGeom>
            <a:avLst/>
            <a:gdLst>
              <a:gd name="connsiteX0" fmla="*/ 0 w 6524082"/>
              <a:gd name="connsiteY0" fmla="*/ 0 h 488935"/>
              <a:gd name="connsiteX1" fmla="*/ 6524083 w 6524082"/>
              <a:gd name="connsiteY1" fmla="*/ 0 h 488935"/>
              <a:gd name="connsiteX2" fmla="*/ 6524083 w 6524082"/>
              <a:gd name="connsiteY2" fmla="*/ 488936 h 488935"/>
              <a:gd name="connsiteX3" fmla="*/ 0 w 6524082"/>
              <a:gd name="connsiteY3" fmla="*/ 488936 h 4889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524082" h="488935">
                <a:moveTo>
                  <a:pt x="0" y="0"/>
                </a:moveTo>
                <a:lnTo>
                  <a:pt x="6524083" y="0"/>
                </a:lnTo>
                <a:lnTo>
                  <a:pt x="6524083" y="488936"/>
                </a:lnTo>
                <a:lnTo>
                  <a:pt x="0" y="488936"/>
                </a:lnTo>
                <a:close/>
              </a:path>
            </a:pathLst>
          </a:custGeom>
          <a:noFill/>
          <a:ln w="7015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5909ED3-88CF-FDBF-1121-03EDFD474BD7}"/>
              </a:ext>
            </a:extLst>
          </p:cNvPr>
          <p:cNvSpPr txBox="1"/>
          <p:nvPr/>
        </p:nvSpPr>
        <p:spPr>
          <a:xfrm>
            <a:off x="385935" y="1178213"/>
            <a:ext cx="6363939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esenteeism:</a:t>
            </a:r>
          </a:p>
          <a:p>
            <a:pPr algn="just"/>
            <a:endParaRPr lang="en-US" altLang="ja-JP" sz="1200" b="1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Q1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n a scale from 0 to 10, where 0 is the worst job performance anyone could have at your job and 10 is the performance of a top worker, how would you rate the usual performance of most workers in a job similar to yours?</a:t>
            </a:r>
          </a:p>
          <a:p>
            <a:pPr algn="just"/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Q2.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sing the same 0-to-10 scale, how would you rate your overall job performance on the days you worked during the past 4 weeks (28 days)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?</a:t>
            </a:r>
          </a:p>
          <a:p>
            <a:pPr indent="279400"/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279400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solute Presenteeism = Q2 ×10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	• • •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quation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1)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279400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ve Presenteeism = Q2 / Q1</a:t>
            </a:r>
            <a:r>
              <a:rPr lang="ja-JP" altLang="en-US" sz="12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	• • •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quation (2)</a:t>
            </a:r>
          </a:p>
          <a:p>
            <a:pPr indent="279400"/>
            <a:endParaRPr lang="en-US" altLang="ja-JP" sz="1200" kern="100" dirty="0">
              <a:solidFill>
                <a:srgbClr val="000000"/>
              </a:solidFill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ja-JP" alt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solute presenteeism is calculated with a minimum value of 0 (total lack of performance during the time on the job) and a maximum value of 100 (no lack of performance). In this scoring, the higher the presenteeism score, the better the work productivity. </a:t>
            </a:r>
          </a:p>
          <a:p>
            <a:r>
              <a:rPr lang="ja-JP" altLang="en-US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ve presenteeism is calculated with a minimum value of 0.25 and a maximum value of 2 to replace values less than 0.25 with 0.25 and values greater than 2.0 with 2.0. A score close to 1 indicates that the employee is performing at the same level as their peers, a high score indicates that they are performing better than their peers, and a low score indicates that they are performing worse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279400"/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6" name="フリーフォーム: 図形 15">
            <a:extLst>
              <a:ext uri="{FF2B5EF4-FFF2-40B4-BE49-F238E27FC236}">
                <a16:creationId xmlns:a16="http://schemas.microsoft.com/office/drawing/2014/main" id="{01729EAB-5E88-7485-F37C-86A69CE2E4BA}"/>
              </a:ext>
            </a:extLst>
          </p:cNvPr>
          <p:cNvSpPr/>
          <p:nvPr/>
        </p:nvSpPr>
        <p:spPr>
          <a:xfrm>
            <a:off x="337614" y="5078897"/>
            <a:ext cx="6390996" cy="2880330"/>
          </a:xfrm>
          <a:custGeom>
            <a:avLst/>
            <a:gdLst>
              <a:gd name="connsiteX0" fmla="*/ 0 w 6524082"/>
              <a:gd name="connsiteY0" fmla="*/ 0 h 488935"/>
              <a:gd name="connsiteX1" fmla="*/ 6524083 w 6524082"/>
              <a:gd name="connsiteY1" fmla="*/ 0 h 488935"/>
              <a:gd name="connsiteX2" fmla="*/ 6524083 w 6524082"/>
              <a:gd name="connsiteY2" fmla="*/ 488936 h 488935"/>
              <a:gd name="connsiteX3" fmla="*/ 0 w 6524082"/>
              <a:gd name="connsiteY3" fmla="*/ 488936 h 4889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524082" h="488935">
                <a:moveTo>
                  <a:pt x="0" y="0"/>
                </a:moveTo>
                <a:lnTo>
                  <a:pt x="6524083" y="0"/>
                </a:lnTo>
                <a:lnTo>
                  <a:pt x="6524083" y="488936"/>
                </a:lnTo>
                <a:lnTo>
                  <a:pt x="0" y="488936"/>
                </a:lnTo>
                <a:close/>
              </a:path>
            </a:pathLst>
          </a:custGeom>
          <a:noFill/>
          <a:ln w="7015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8A036A9-E53C-1B7E-204A-5726B4DC165F}"/>
              </a:ext>
            </a:extLst>
          </p:cNvPr>
          <p:cNvSpPr txBox="1"/>
          <p:nvPr/>
        </p:nvSpPr>
        <p:spPr>
          <a:xfrm>
            <a:off x="385935" y="5096905"/>
            <a:ext cx="636393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</a:t>
            </a: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enteeism:</a:t>
            </a:r>
          </a:p>
          <a:p>
            <a:pPr algn="just"/>
            <a:endParaRPr lang="en-US" altLang="ja-JP" sz="1200" b="1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Q3. How many hours does your employer expect you to work in a typical 7-day week? If it varies, estimate the average. If it is more than 97, enter 97.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Q4. About how many hours altogether did you work in the past 4 weeks (28 days)? </a:t>
            </a:r>
          </a:p>
          <a:p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279400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solute Presenteeism = Q2 ×10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	• • • </a:t>
            </a:r>
            <a:r>
              <a:rPr lang="en-US" altLang="ja-JP" sz="12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quation</a:t>
            </a:r>
            <a:r>
              <a:rPr lang="en-US" altLang="ja-JP" sz="1200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)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279400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ve Presenteeism = Q2 / Q1</a:t>
            </a:r>
            <a:r>
              <a:rPr lang="ja-JP" altLang="en-US" sz="12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	• • •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quation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4)</a:t>
            </a:r>
          </a:p>
          <a:p>
            <a:pPr indent="279400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ja-JP" altLang="en-US" sz="12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In these calculations, positive and larger values indicate more absenteeism. Negative and smaller values indicate more work than expected. A value of 0 means that the employee worked the same amount of expected work hours, indicating no absenteeism. </a:t>
            </a:r>
          </a:p>
          <a:p>
            <a:r>
              <a:rPr lang="ja-JP" altLang="en-US" sz="12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Qualitatively, the same goes for relative absenteeism; however, a value of 1 means that the worker was always absent from work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5372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11</TotalTime>
  <Words>402</Words>
  <Application>Microsoft Macintosh PowerPoint</Application>
  <PresentationFormat>ユーザー設定</PresentationFormat>
  <Paragraphs>2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正木 克宜</dc:creator>
  <cp:lastModifiedBy>Katsunori Masaki</cp:lastModifiedBy>
  <cp:revision>7</cp:revision>
  <dcterms:created xsi:type="dcterms:W3CDTF">2024-03-15T15:51:48Z</dcterms:created>
  <dcterms:modified xsi:type="dcterms:W3CDTF">2024-09-23T15:12:49Z</dcterms:modified>
</cp:coreProperties>
</file>